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9"/>
  </p:normalViewPr>
  <p:slideViewPr>
    <p:cSldViewPr snapToGrid="0" snapToObjects="1">
      <p:cViewPr varScale="1">
        <p:scale>
          <a:sx n="117" d="100"/>
          <a:sy n="117" d="100"/>
        </p:scale>
        <p:origin x="3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F$1</c:f>
                <c:numCache>
                  <c:formatCode>General</c:formatCode>
                  <c:ptCount val="1"/>
                  <c:pt idx="0">
                    <c:v>12.5</c:v>
                  </c:pt>
                </c:numCache>
              </c:numRef>
            </c:plus>
            <c:minus>
              <c:numRef>
                <c:f>Blad1!$F$2</c:f>
                <c:numCache>
                  <c:formatCode>General</c:formatCode>
                  <c:ptCount val="1"/>
                  <c:pt idx="0">
                    <c:v>10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5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74-6547-92EE-3F823BECC187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6.9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5.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174-6547-92EE-3F823BECC187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4.2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3.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2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174-6547-92EE-3F823BECC1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7270056"/>
        <c:axId val="397268880"/>
      </c:barChart>
      <c:catAx>
        <c:axId val="397270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7268880"/>
        <c:crosses val="autoZero"/>
        <c:auto val="1"/>
        <c:lblAlgn val="ctr"/>
        <c:lblOffset val="100"/>
        <c:noMultiLvlLbl val="0"/>
      </c:catAx>
      <c:valAx>
        <c:axId val="39726888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727005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11.7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9.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49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C4-9D4B-ABDB-BF2A56F71D35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9.1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7.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39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C4-9D4B-ABDB-BF2A56F71D35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I$1</c:f>
                <c:numCache>
                  <c:formatCode>General</c:formatCode>
                  <c:ptCount val="1"/>
                  <c:pt idx="0">
                    <c:v>6.3</c:v>
                  </c:pt>
                </c:numCache>
              </c:numRef>
            </c:plus>
            <c:minus>
              <c:numRef>
                <c:f>Blad1!$I$2</c:f>
                <c:numCache>
                  <c:formatCode>General</c:formatCode>
                  <c:ptCount val="1"/>
                  <c:pt idx="0">
                    <c:v>5.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2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C4-9D4B-ABDB-BF2A56F71D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7271232"/>
        <c:axId val="397271624"/>
      </c:barChart>
      <c:catAx>
        <c:axId val="397271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7271624"/>
        <c:crosses val="autoZero"/>
        <c:auto val="1"/>
        <c:lblAlgn val="ctr"/>
        <c:lblOffset val="100"/>
        <c:noMultiLvlLbl val="0"/>
      </c:catAx>
      <c:valAx>
        <c:axId val="39727162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972712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08DE0-F78B-9F4E-936D-11A7160419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97AE17-FE81-5148-80CA-5BA31FE4E2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AF97D-7313-814E-8238-EFCDA35A2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C3D811-1980-D744-80CB-4B4EA3E8A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FAF6E1-3765-D34B-BE0C-38695256DB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0439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89E0D-8BED-324C-9366-43ACB1308C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0A48BF-61EE-1546-B13C-BD0E2D36DA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442996-AFA8-6849-8503-4DA00B131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827CE-8888-1F45-8049-ABB2893EE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359570-756B-254A-B0CB-20B654D4C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48712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0D3AA8-5D8B-A749-8810-E22FA03D74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9D4F58-3928-EA42-B4A0-931EF19D40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940DC-FBBD-E147-A053-CF821A751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F5C114-EA09-1E41-A4AE-AB473B60C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99B0B-9AB5-D547-BCB0-364B3E745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39297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16D78-2136-5A48-9FF6-CD84E8CEDB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64408E-4BC2-1D42-BDE8-723FDD4B57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741908-8FB9-7543-ADB6-8220FFAB1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245438-3D13-744C-8507-56A61048B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E57975-5FB0-FC4E-B8AC-6F468B289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9864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5EEFD-33F9-4F41-A8D5-1F515995F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F025FB-77BA-B340-B476-E02E23348F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3B145-2F78-F44E-A36C-FCE8760A9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365AA2-62C1-9F4D-9EF7-D57F655D6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9497BA-206E-0E4B-914A-CBB0F0523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92472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B74339-93C0-B94D-94F9-FA4085EBAD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F0B425-10E0-AB4A-B124-5484831A5F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5161E9-6D11-6747-BB39-9D7F657F4C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6C329A-57D2-9D4E-9868-CE9A8D878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340229-D3AF-5B4C-9E60-92FED15EE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37D234-16E6-2642-8E67-EF1C30643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9642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EC7B7A-753A-EC4F-967E-AE66372A2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3404D4-80B8-1A47-BC27-643419ED8B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A98FF5-F047-2E43-B02F-C111BADD32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78459D-B71B-C243-97C2-84AAA7654B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0FB4EB-A6E1-0348-8FF4-368AF3ED40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38E502-102C-744B-AE53-EAE7F023D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D36F54-2515-C14D-B6BF-2CACA4775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80491E8-E1E8-494B-8E4B-77AD07275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62905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DCF95-225A-1948-B0BF-D3370CB528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5B8B21-A1C1-2D4F-8E40-A6E539C211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59C897-86B7-DB4A-85A7-2B346D4EB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C07B04-0C6B-EB49-838F-D1DB327D5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66762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7C4301-B3A2-024B-8037-9E8228816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CC5942-93FA-8940-BE4C-3A634FCF8C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DD3B16-B623-A44C-8B91-E4C9DCE8D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46699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F35E2D-15F6-CC4A-94BC-B1DD091D5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549F1A-CF39-8C4E-A369-02F5A9A74B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29317F-1ED9-B24A-BB5D-8A0CDB5549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F46F0B-704E-EA40-8D8B-64600E01D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36CF56-E59C-3E4F-85F9-3B0FFE6C4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71E30D-D13A-E44D-A20A-3B784F115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45994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7BCFB3-CD17-DB4A-B31C-BFF396F9F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C60D07-5164-AA41-890E-A676166AEE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60592A-D2B2-2347-AE9B-A8C17EA5F8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C0202D-7F96-8E41-93EF-7E8CEC85E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A6147C-1420-A24E-926D-30AC555A3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412FEE-2B11-764B-A466-A65C3F29F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80566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A1F3E9-E688-A345-9877-300FAD394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C1CB39-36DE-F74A-841E-AB625D0721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7303D-0319-DB4E-ABF3-327292A290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C6703-BAE5-424F-BB36-74E84ED4092A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38BF72-9A5D-F14A-B2EE-484F81E7B6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F858E4-1160-4843-B658-90D55099C9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1F3BC-4E36-4A4B-8BFD-DEC0FC36E90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082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Platshållare för innehåll 8"/>
          <p:cNvGraphicFramePr>
            <a:graphicFrameLocks noGrp="1"/>
          </p:cNvGraphicFramePr>
          <p:nvPr>
            <p:ph sz="half" idx="1"/>
            <p:extLst/>
          </p:nvPr>
        </p:nvGraphicFramePr>
        <p:xfrm>
          <a:off x="21526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Platshållare för innehåll 11"/>
          <p:cNvGraphicFramePr>
            <a:graphicFrameLocks noGrp="1"/>
          </p:cNvGraphicFramePr>
          <p:nvPr>
            <p:ph sz="half" idx="2"/>
            <p:extLst/>
          </p:nvPr>
        </p:nvGraphicFramePr>
        <p:xfrm>
          <a:off x="61531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">
            <a:extLst>
              <a:ext uri="{FF2B5EF4-FFF2-40B4-BE49-F238E27FC236}">
                <a16:creationId xmlns:a16="http://schemas.microsoft.com/office/drawing/2014/main" id="{BBC6F2A3-B042-9E41-9FDE-2935D1BC485A}"/>
              </a:ext>
            </a:extLst>
          </p:cNvPr>
          <p:cNvSpPr txBox="1"/>
          <p:nvPr/>
        </p:nvSpPr>
        <p:spPr>
          <a:xfrm>
            <a:off x="1664614" y="228600"/>
            <a:ext cx="492443" cy="579447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2000" dirty="0" err="1"/>
              <a:t>Lundex</a:t>
            </a:r>
            <a:r>
              <a:rPr lang="sv-SE" sz="2000" dirty="0"/>
              <a:t>  DAS 28 </a:t>
            </a:r>
            <a:r>
              <a:rPr lang="sv-SE" sz="2000" dirty="0" err="1"/>
              <a:t>low</a:t>
            </a:r>
            <a:r>
              <a:rPr lang="sv-SE" sz="2000" dirty="0"/>
              <a:t> </a:t>
            </a:r>
            <a:r>
              <a:rPr lang="sv-SE" sz="2000" dirty="0" err="1"/>
              <a:t>disease</a:t>
            </a:r>
            <a:r>
              <a:rPr lang="sv-SE" sz="2000" dirty="0"/>
              <a:t> </a:t>
            </a:r>
            <a:r>
              <a:rPr lang="sv-SE" sz="2000" dirty="0" err="1"/>
              <a:t>activity</a:t>
            </a:r>
            <a:r>
              <a:rPr lang="sv-SE" sz="2000" dirty="0"/>
              <a:t> : proportions (%)</a:t>
            </a:r>
          </a:p>
        </p:txBody>
      </p:sp>
      <p:sp>
        <p:nvSpPr>
          <p:cNvPr id="14" name="textruta 13"/>
          <p:cNvSpPr txBox="1"/>
          <p:nvPr/>
        </p:nvSpPr>
        <p:spPr>
          <a:xfrm>
            <a:off x="3046442" y="6023072"/>
            <a:ext cx="93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5" name="textruta 14"/>
          <p:cNvSpPr txBox="1"/>
          <p:nvPr/>
        </p:nvSpPr>
        <p:spPr>
          <a:xfrm>
            <a:off x="3801867" y="6023072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16" name="textruta 15"/>
          <p:cNvSpPr txBox="1"/>
          <p:nvPr/>
        </p:nvSpPr>
        <p:spPr>
          <a:xfrm>
            <a:off x="4461818" y="6029713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18" name="textruta 17"/>
          <p:cNvSpPr txBox="1"/>
          <p:nvPr/>
        </p:nvSpPr>
        <p:spPr>
          <a:xfrm>
            <a:off x="6978505" y="6029713"/>
            <a:ext cx="93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9" name="textruta 18"/>
          <p:cNvSpPr txBox="1"/>
          <p:nvPr/>
        </p:nvSpPr>
        <p:spPr>
          <a:xfrm>
            <a:off x="7782981" y="6023073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20" name="textruta 19"/>
          <p:cNvSpPr txBox="1"/>
          <p:nvPr/>
        </p:nvSpPr>
        <p:spPr>
          <a:xfrm>
            <a:off x="8495821" y="6023072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21" name="textruta 20"/>
          <p:cNvSpPr txBox="1"/>
          <p:nvPr/>
        </p:nvSpPr>
        <p:spPr>
          <a:xfrm>
            <a:off x="3533774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6 </a:t>
            </a:r>
            <a:r>
              <a:rPr lang="sv-SE" sz="2000" dirty="0" err="1"/>
              <a:t>months</a:t>
            </a:r>
            <a:endParaRPr lang="sv-SE" sz="2000" dirty="0"/>
          </a:p>
        </p:txBody>
      </p:sp>
      <p:sp>
        <p:nvSpPr>
          <p:cNvPr id="22" name="textruta 21"/>
          <p:cNvSpPr txBox="1"/>
          <p:nvPr/>
        </p:nvSpPr>
        <p:spPr>
          <a:xfrm>
            <a:off x="7337595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12 </a:t>
            </a:r>
            <a:r>
              <a:rPr lang="sv-SE" sz="2000" dirty="0" err="1"/>
              <a:t>months</a:t>
            </a:r>
            <a:endParaRPr lang="sv-SE" sz="2000" dirty="0"/>
          </a:p>
        </p:txBody>
      </p:sp>
    </p:spTree>
    <p:extLst>
      <p:ext uri="{BB962C8B-B14F-4D97-AF65-F5344CB8AC3E}">
        <p14:creationId xmlns:p14="http://schemas.microsoft.com/office/powerpoint/2010/main" val="601094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5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undex corrected DAS 28 low disease activity</dc:title>
  <dc:creator>Giovanni Cagnotto</dc:creator>
  <cp:lastModifiedBy>Giovanni Cagnotto</cp:lastModifiedBy>
  <cp:revision>8</cp:revision>
  <cp:lastPrinted>2019-09-02T22:54:50Z</cp:lastPrinted>
  <dcterms:created xsi:type="dcterms:W3CDTF">2019-08-15T22:09:29Z</dcterms:created>
  <dcterms:modified xsi:type="dcterms:W3CDTF">2019-12-09T12:11:07Z</dcterms:modified>
</cp:coreProperties>
</file>